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71" r:id="rId2"/>
    <p:sldId id="265" r:id="rId3"/>
    <p:sldId id="283" r:id="rId4"/>
    <p:sldId id="287" r:id="rId5"/>
    <p:sldId id="288" r:id="rId6"/>
    <p:sldId id="286" r:id="rId7"/>
    <p:sldId id="289" r:id="rId8"/>
    <p:sldId id="284" r:id="rId9"/>
    <p:sldId id="281" r:id="rId10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  <a:srgbClr val="00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22" autoAdjust="0"/>
    <p:restoredTop sz="94658"/>
  </p:normalViewPr>
  <p:slideViewPr>
    <p:cSldViewPr>
      <p:cViewPr varScale="1">
        <p:scale>
          <a:sx n="83" d="100"/>
          <a:sy n="83" d="100"/>
        </p:scale>
        <p:origin x="-3204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2" d="100"/>
        <a:sy n="17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17FD6E-0A20-41FE-A9AA-50AD1FD6C0F1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F03FC2-407E-4EC1-A06C-67C43200FF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2133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4756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9127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0333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2326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7328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4751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5743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5060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4244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1920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8157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DAB232-5ECF-48A8-86A9-C5EEBDA13392}" type="datetimeFigureOut">
              <a:rPr lang="en-GB" smtClean="0"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B3C09-BD14-465C-AE3D-7EA191A9AA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2796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microsoft.com/office/2007/relationships/hdphoto" Target="../media/hdphoto1.wdp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5" Type="http://schemas.openxmlformats.org/officeDocument/2006/relationships/image" Target="../media/image35.emf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Relationship Id="rId14" Type="http://schemas.openxmlformats.org/officeDocument/2006/relationships/image" Target="../media/image3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0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MOMELAP2\AppData\Local\Microsoft\Windows\Temporary Internet Files\Content.Outlook\U1SPA07C\iTTFs_combined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0537" y="1415517"/>
            <a:ext cx="3078503" cy="17737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MOMELAP2\AppData\Local\Microsoft\Windows\Temporary Internet Files\Content.Outlook\U1SPA07C\MEFs_combined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0537" y="3212758"/>
            <a:ext cx="3078503" cy="17737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4" descr="C:\Users\MOMELAP2\AppData\Local\Microsoft\Windows\Temporary Internet Files\Content.Outlook\U1SPA07C\Tail tendon_combined.tif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0537" y="4958493"/>
            <a:ext cx="3078503" cy="17737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20688" y="7092280"/>
            <a:ext cx="604867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hythmic expression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Levels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normalized to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Red) in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iTTF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EFs and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ail tendons, using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ircwav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o identify the best fit harmonic curves (Black). 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)-F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alysis of Chip-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data from Koike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Ref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3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hich examined the genome wide binding of core clock components over 24 hours; the binding of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Cry2,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)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F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NA polymerase II,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o the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Hspa5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promoter.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10538" y="1326305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10537" y="3054497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10536" y="4782689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81"/>
          <a:stretch/>
        </p:blipFill>
        <p:spPr bwMode="auto">
          <a:xfrm>
            <a:off x="3861048" y="1104499"/>
            <a:ext cx="2736304" cy="1949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1048" y="4547223"/>
            <a:ext cx="2736304" cy="25450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100"/>
          <a:stretch/>
        </p:blipFill>
        <p:spPr bwMode="auto">
          <a:xfrm>
            <a:off x="3941960" y="2886789"/>
            <a:ext cx="2574480" cy="19042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3834232" y="1326305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834231" y="3054497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834230" y="4782689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327004" y="1475656"/>
            <a:ext cx="1944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Cry2 binding to </a:t>
            </a:r>
            <a:r>
              <a:rPr lang="en-GB" sz="1200" b="1" i="1" dirty="0"/>
              <a:t>Hspa5</a:t>
            </a:r>
            <a:endParaRPr lang="en-GB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4327004" y="3260411"/>
            <a:ext cx="1944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/>
              <a:t>Cbp</a:t>
            </a:r>
            <a:r>
              <a:rPr lang="en-GB" sz="1200" b="1" dirty="0"/>
              <a:t> binding to </a:t>
            </a:r>
            <a:r>
              <a:rPr lang="en-GB" sz="1200" b="1" i="1" dirty="0"/>
              <a:t>Hspa5</a:t>
            </a:r>
            <a:endParaRPr lang="en-GB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327004" y="4958493"/>
            <a:ext cx="1944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RNA </a:t>
            </a:r>
            <a:r>
              <a:rPr lang="en-GB" sz="1200" b="1" dirty="0" err="1"/>
              <a:t>polII</a:t>
            </a:r>
            <a:r>
              <a:rPr lang="en-GB" sz="1200" b="1" dirty="0"/>
              <a:t> binding to </a:t>
            </a:r>
            <a:r>
              <a:rPr lang="en-GB" sz="1200" b="1" i="1" dirty="0"/>
              <a:t>Hspa5</a:t>
            </a:r>
            <a:endParaRPr lang="en-GB" sz="1200" b="1" dirty="0"/>
          </a:p>
        </p:txBody>
      </p:sp>
      <p:sp>
        <p:nvSpPr>
          <p:cNvPr id="8" name="Rectangle 7"/>
          <p:cNvSpPr/>
          <p:nvPr/>
        </p:nvSpPr>
        <p:spPr>
          <a:xfrm>
            <a:off x="2736304" y="1415517"/>
            <a:ext cx="3429000" cy="452431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dirty="0"/>
              <a:t>p</a:t>
            </a:r>
            <a:r>
              <a:rPr lang="en-GB" dirty="0" smtClean="0"/>
              <a:t>= 0.0202</a:t>
            </a:r>
          </a:p>
          <a:p>
            <a:r>
              <a:rPr lang="en-GB" dirty="0" smtClean="0"/>
              <a:t>R</a:t>
            </a:r>
            <a:r>
              <a:rPr lang="en-GB" baseline="30000" dirty="0" smtClean="0"/>
              <a:t>2</a:t>
            </a:r>
            <a:r>
              <a:rPr lang="en-GB" dirty="0" smtClean="0"/>
              <a:t>= 0.97</a:t>
            </a:r>
            <a:endParaRPr lang="en-GB" dirty="0"/>
          </a:p>
          <a:p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r>
              <a:rPr lang="en-GB" dirty="0" smtClean="0"/>
              <a:t>p</a:t>
            </a:r>
            <a:r>
              <a:rPr lang="en-GB" dirty="0"/>
              <a:t>= 0.0058</a:t>
            </a:r>
          </a:p>
          <a:p>
            <a:r>
              <a:rPr lang="en-GB" dirty="0"/>
              <a:t>R</a:t>
            </a:r>
            <a:r>
              <a:rPr lang="en-GB" baseline="30000" dirty="0"/>
              <a:t>2</a:t>
            </a:r>
            <a:r>
              <a:rPr lang="en-GB" dirty="0"/>
              <a:t>= 0.93</a:t>
            </a:r>
          </a:p>
          <a:p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endParaRPr lang="en-GB" dirty="0"/>
          </a:p>
          <a:p>
            <a:r>
              <a:rPr lang="en-GB" dirty="0" smtClean="0"/>
              <a:t>p= 0.4567</a:t>
            </a:r>
          </a:p>
          <a:p>
            <a:r>
              <a:rPr lang="en-GB" dirty="0"/>
              <a:t>R</a:t>
            </a:r>
            <a:r>
              <a:rPr lang="en-GB" baseline="30000" dirty="0"/>
              <a:t>2</a:t>
            </a:r>
            <a:r>
              <a:rPr lang="en-GB" dirty="0"/>
              <a:t>= </a:t>
            </a:r>
            <a:r>
              <a:rPr lang="en-GB" dirty="0" smtClean="0"/>
              <a:t>0.41</a:t>
            </a:r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13919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01008" y="251520"/>
            <a:ext cx="3096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/>
              <a:t>Supplementary Figure 2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4181141"/>
              </p:ext>
            </p:extLst>
          </p:nvPr>
        </p:nvGraphicFramePr>
        <p:xfrm>
          <a:off x="3284984" y="444118"/>
          <a:ext cx="3443287" cy="3238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8" name="Prism 7" r:id="rId3" imgW="3443978" imgH="3238505" progId="Prism7.Document">
                  <p:embed/>
                </p:oleObj>
              </mc:Choice>
              <mc:Fallback>
                <p:oleObj name="Prism 7" r:id="rId3" imgW="3443978" imgH="323850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84984" y="444118"/>
                        <a:ext cx="3443287" cy="3238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1084063"/>
              </p:ext>
            </p:extLst>
          </p:nvPr>
        </p:nvGraphicFramePr>
        <p:xfrm>
          <a:off x="-41579" y="447887"/>
          <a:ext cx="3443287" cy="3238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9" name="Prism 7" r:id="rId5" imgW="3443978" imgH="3238505" progId="Prism7.Document">
                  <p:embed/>
                </p:oleObj>
              </mc:Choice>
              <mc:Fallback>
                <p:oleObj name="Prism 7" r:id="rId5" imgW="3443978" imgH="323850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41579" y="447887"/>
                        <a:ext cx="3443287" cy="3238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71084" y="3635896"/>
            <a:ext cx="5661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Levels of CHOP/DDIT3, spliced XBP1 (Xbp1s) and ATF6 indicate that the unfolded protein response has been activated following 5 hours treatment with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hapsigargin and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100 ng/mL tunicamycin.  * indicates p&lt;0.05, ** indicates p&lt;0.01, paired t-test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4624" y="539552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356992" y="539552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138461" y="908884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u="sng" dirty="0"/>
              <a:t> ** </a:t>
            </a:r>
            <a:r>
              <a:rPr lang="en-GB" sz="1200" u="sng" dirty="0">
                <a:solidFill>
                  <a:schemeClr val="bg1"/>
                </a:solidFill>
              </a:rPr>
              <a:t> *</a:t>
            </a:r>
            <a:r>
              <a:rPr lang="en-GB" sz="1200" u="sng" dirty="0"/>
              <a:t>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714525" y="78391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u="sng" dirty="0"/>
              <a:t> ** </a:t>
            </a:r>
            <a:r>
              <a:rPr lang="en-GB" sz="1200" u="sng" dirty="0">
                <a:solidFill>
                  <a:schemeClr val="bg1"/>
                </a:solidFill>
              </a:rPr>
              <a:t> *</a:t>
            </a:r>
            <a:r>
              <a:rPr lang="en-GB" sz="1200" u="sng" dirty="0"/>
              <a:t>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25644" y="196066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u="sng" dirty="0"/>
              <a:t>  *  </a:t>
            </a:r>
            <a:r>
              <a:rPr lang="en-GB" sz="1200" u="sng" dirty="0">
                <a:solidFill>
                  <a:schemeClr val="bg1"/>
                </a:solidFill>
              </a:rPr>
              <a:t> *</a:t>
            </a:r>
            <a:r>
              <a:rPr lang="en-GB" sz="1200" u="sng" dirty="0"/>
              <a:t>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465687" y="70366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u="sng" dirty="0"/>
              <a:t> ** </a:t>
            </a:r>
            <a:r>
              <a:rPr lang="en-GB" sz="1200" u="sng" dirty="0">
                <a:solidFill>
                  <a:schemeClr val="bg1"/>
                </a:solidFill>
              </a:rPr>
              <a:t> *</a:t>
            </a:r>
            <a:r>
              <a:rPr lang="en-GB" sz="1200" u="sng" dirty="0"/>
              <a:t>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041540" y="93740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u="sng" dirty="0"/>
              <a:t> ** </a:t>
            </a:r>
            <a:r>
              <a:rPr lang="en-GB" sz="1200" u="sng" dirty="0">
                <a:solidFill>
                  <a:schemeClr val="bg1"/>
                </a:solidFill>
              </a:rPr>
              <a:t> *</a:t>
            </a:r>
            <a:r>
              <a:rPr lang="en-GB" sz="1200" u="sng" dirty="0"/>
              <a:t>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137082" y="146079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u="sng" dirty="0"/>
              <a:t>  *  </a:t>
            </a:r>
            <a:r>
              <a:rPr lang="en-GB" sz="1200" u="sng" dirty="0">
                <a:solidFill>
                  <a:schemeClr val="bg1"/>
                </a:solidFill>
              </a:rPr>
              <a:t> *</a:t>
            </a:r>
            <a:r>
              <a:rPr lang="en-GB" sz="1200" u="sng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74200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88640" y="5074142"/>
            <a:ext cx="6155340" cy="2407606"/>
            <a:chOff x="2631875" y="5940766"/>
            <a:chExt cx="3680376" cy="1439546"/>
          </a:xfrm>
        </p:grpSpPr>
        <p:pic>
          <p:nvPicPr>
            <p:cNvPr id="5" name="Picture 6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431"/>
            <a:stretch/>
          </p:blipFill>
          <p:spPr bwMode="auto">
            <a:xfrm>
              <a:off x="2631875" y="5940766"/>
              <a:ext cx="2317912" cy="12955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454" t="2321" r="54971" b="91861"/>
            <a:stretch/>
          </p:blipFill>
          <p:spPr bwMode="auto">
            <a:xfrm>
              <a:off x="4612575" y="6156176"/>
              <a:ext cx="330870" cy="13967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57" t="15513" r="78668" b="78669"/>
            <a:stretch/>
          </p:blipFill>
          <p:spPr bwMode="auto">
            <a:xfrm>
              <a:off x="4586685" y="6453461"/>
              <a:ext cx="330870" cy="1396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72" t="21332" r="65705" b="70911"/>
            <a:stretch/>
          </p:blipFill>
          <p:spPr bwMode="auto">
            <a:xfrm>
              <a:off x="4676904" y="6588675"/>
              <a:ext cx="268681" cy="1862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35" t="26458" r="77342" b="65785"/>
            <a:stretch/>
          </p:blipFill>
          <p:spPr bwMode="auto">
            <a:xfrm>
              <a:off x="4684312" y="6678805"/>
              <a:ext cx="268681" cy="1862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70" t="34146" r="65707" b="58097"/>
            <a:stretch/>
          </p:blipFill>
          <p:spPr bwMode="auto">
            <a:xfrm>
              <a:off x="4679860" y="6857248"/>
              <a:ext cx="268681" cy="1862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454" t="9446" r="54971" b="86043"/>
            <a:stretch/>
          </p:blipFill>
          <p:spPr bwMode="auto">
            <a:xfrm>
              <a:off x="4612575" y="6319018"/>
              <a:ext cx="330870" cy="1082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897114" y="6164910"/>
              <a:ext cx="1415137" cy="121540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4"/>
            <a:srcRect l="55011" t="2584" r="2515" b="87511"/>
            <a:stretch/>
          </p:blipFill>
          <p:spPr>
            <a:xfrm>
              <a:off x="5674923" y="6341070"/>
              <a:ext cx="601063" cy="120372"/>
            </a:xfrm>
            <a:prstGeom prst="rect">
              <a:avLst/>
            </a:prstGeom>
          </p:spPr>
        </p:pic>
      </p:grpSp>
      <p:sp>
        <p:nvSpPr>
          <p:cNvPr id="21" name="TextBox 20"/>
          <p:cNvSpPr txBox="1"/>
          <p:nvPr/>
        </p:nvSpPr>
        <p:spPr>
          <a:xfrm>
            <a:off x="260648" y="7538844"/>
            <a:ext cx="604356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fter 5 hours treatment with 1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hapsigargin Per2::Luc cells were synchronized with 10 µM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orskol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fter synchronizing Per2::Luc cells with dexamethasone, bioluminescence was measured for 24 hours thereafter cells were treated with DMSO or 1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hapsigargin, as in Figure 1E.  The treatment is indicated by the dashed line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s B but with 2 hours treatment with 50% serum as the synchronizing event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s B but with 2 hours treatment with 10 µM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orskol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s the synchronizing event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Circadian rhythm can be induced in cells which received 5 hours thapsigargin following 24/48 hours recovery.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7163" y="-32677"/>
            <a:ext cx="769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7163" y="4974332"/>
            <a:ext cx="769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09" y="57059"/>
            <a:ext cx="3528843" cy="23196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645" y="2714883"/>
            <a:ext cx="3639164" cy="2556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5218" y="162401"/>
            <a:ext cx="3488198" cy="25853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1527" y="2597908"/>
            <a:ext cx="3483843" cy="26941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3293666" y="-32677"/>
            <a:ext cx="769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7163" y="2426579"/>
            <a:ext cx="769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292355" y="2395187"/>
            <a:ext cx="769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4896594" y="336655"/>
            <a:ext cx="0" cy="185812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1375058" y="2877874"/>
            <a:ext cx="0" cy="185812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4862304" y="2924110"/>
            <a:ext cx="0" cy="185812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4301535" y="467544"/>
            <a:ext cx="7116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/>
              <a:t>Dex</a:t>
            </a:r>
            <a:endParaRPr lang="en-GB" sz="10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620688" y="2627784"/>
            <a:ext cx="10111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50%Serum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157519" y="2809518"/>
            <a:ext cx="10111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/>
              <a:t>Forskolin</a:t>
            </a:r>
            <a:endParaRPr lang="en-GB" sz="10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4037092" y="7221339"/>
            <a:ext cx="1086192" cy="216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000" b="1" dirty="0"/>
              <a:t>Initial Treatment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199484" y="7221339"/>
            <a:ext cx="1086192" cy="216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000" b="1" dirty="0"/>
              <a:t>Synchronization</a:t>
            </a:r>
          </a:p>
        </p:txBody>
      </p:sp>
    </p:spTree>
    <p:extLst>
      <p:ext uri="{BB962C8B-B14F-4D97-AF65-F5344CB8AC3E}">
        <p14:creationId xmlns:p14="http://schemas.microsoft.com/office/powerpoint/2010/main" val="22638229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5C3F0D44-066D-7847-9E48-C48C5B732097}"/>
              </a:ext>
            </a:extLst>
          </p:cNvPr>
          <p:cNvSpPr txBox="1"/>
          <p:nvPr/>
        </p:nvSpPr>
        <p:spPr>
          <a:xfrm>
            <a:off x="260647" y="7169512"/>
            <a:ext cx="6043563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 Effects 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of synchronizing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gents on collagen fibre production. 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ercentage of cells with associated collagen fibres following 72 hours culture in the absence of synchronization (-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Dex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or with 10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Dexamethasone (+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Dex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50% serum shock or 10 µM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orskolin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As assessed by immunofluorescence. N=2, 5 regions per samples measured each including at least 200 cells ** indicates p&lt;0.01, paired t-test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effects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dibutyryl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AM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DB-CAMP), a cell-permeabl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AM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nalogue, on the assembly of collagen fibres. Addition of DB-CAMP alone inhibits collagen fibre assembly but also prevents the induction of assembly by dexamethasone.  N=3 for DB-CAMP alone, N=4 for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DB-CAMP+Dexamethason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** indicates p&lt;0.01, paired t-test. 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224406" y="179512"/>
            <a:ext cx="3240360" cy="3597938"/>
            <a:chOff x="1268760" y="251520"/>
            <a:chExt cx="4176464" cy="4637342"/>
          </a:xfrm>
        </p:grpSpPr>
        <p:cxnSp>
          <p:nvCxnSpPr>
            <p:cNvPr id="3" name="Straight Connector 2"/>
            <p:cNvCxnSpPr/>
            <p:nvPr/>
          </p:nvCxnSpPr>
          <p:spPr>
            <a:xfrm>
              <a:off x="2204864" y="1763688"/>
              <a:ext cx="129614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/>
            <p:cNvSpPr txBox="1"/>
            <p:nvPr/>
          </p:nvSpPr>
          <p:spPr>
            <a:xfrm>
              <a:off x="2348880" y="1403648"/>
              <a:ext cx="9361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/>
                <a:t>**</a:t>
              </a:r>
            </a:p>
          </p:txBody>
        </p:sp>
        <p:pic>
          <p:nvPicPr>
            <p:cNvPr id="512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68760" y="251520"/>
              <a:ext cx="4176464" cy="46373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7" name="Straight Connector 6"/>
            <p:cNvCxnSpPr/>
            <p:nvPr/>
          </p:nvCxnSpPr>
          <p:spPr>
            <a:xfrm>
              <a:off x="2240868" y="1331640"/>
              <a:ext cx="19802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2384884" y="971600"/>
              <a:ext cx="9361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/>
                <a:t>**</a:t>
              </a:r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2240868" y="899592"/>
              <a:ext cx="29163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2384884" y="539552"/>
              <a:ext cx="9361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 err="1"/>
                <a:t>n.s</a:t>
              </a:r>
              <a:r>
                <a:rPr lang="en-GB" dirty="0"/>
                <a:t>.</a:t>
              </a: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428140" y="3419872"/>
            <a:ext cx="3036626" cy="2897035"/>
            <a:chOff x="467544" y="524946"/>
            <a:chExt cx="4206644" cy="4013275"/>
          </a:xfrm>
        </p:grpSpPr>
        <p:pic>
          <p:nvPicPr>
            <p:cNvPr id="13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7544" y="894793"/>
              <a:ext cx="2072760" cy="15486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5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79779" y="894793"/>
              <a:ext cx="2072760" cy="15486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9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9193" y="2989605"/>
              <a:ext cx="2072757" cy="15486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6" name="Straight Connector 15"/>
            <p:cNvCxnSpPr/>
            <p:nvPr/>
          </p:nvCxnSpPr>
          <p:spPr>
            <a:xfrm>
              <a:off x="2152316" y="2314666"/>
              <a:ext cx="29265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1836776" y="1987675"/>
              <a:ext cx="889047" cy="3837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chemeClr val="bg1"/>
                  </a:solidFill>
                </a:rPr>
                <a:t>20 µm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67545" y="524946"/>
              <a:ext cx="2072760" cy="3837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untreated</a:t>
              </a:r>
            </a:p>
          </p:txBody>
        </p:sp>
        <p:pic>
          <p:nvPicPr>
            <p:cNvPr id="19" name="Picture 12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01429" y="2989606"/>
              <a:ext cx="2072757" cy="15486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" name="TextBox 19"/>
            <p:cNvSpPr txBox="1"/>
            <p:nvPr/>
          </p:nvSpPr>
          <p:spPr>
            <a:xfrm>
              <a:off x="2551145" y="524946"/>
              <a:ext cx="2072760" cy="3837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Dexamethasone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88571" y="2668821"/>
              <a:ext cx="2072757" cy="3837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10 µM DB-CAMP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601430" y="2391822"/>
              <a:ext cx="2072758" cy="646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10 µM DB-CAMP + Dexamethasone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44624" y="32352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4624" y="3635896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8468" y="3558371"/>
            <a:ext cx="3444875" cy="39385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762955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8760" y="1835696"/>
            <a:ext cx="3904881" cy="2451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63284" y="4195117"/>
            <a:ext cx="62012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Reduced ER stress in Clock 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19 tendons. 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NA was isolated from tendons of wild-type (WT) and Clock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19 (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19) mice.  Real-time PCR for ER stress related transcripts are shown.</a:t>
            </a:r>
          </a:p>
        </p:txBody>
      </p:sp>
    </p:spTree>
    <p:extLst>
      <p:ext uri="{BB962C8B-B14F-4D97-AF65-F5344CB8AC3E}">
        <p14:creationId xmlns:p14="http://schemas.microsoft.com/office/powerpoint/2010/main" val="37415009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0440" y="702715"/>
            <a:ext cx="1474048" cy="1101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999" y="693302"/>
            <a:ext cx="1474048" cy="1101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8458" y="702715"/>
            <a:ext cx="1474048" cy="1101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3728" y="693302"/>
            <a:ext cx="1474048" cy="1101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0440" y="1861595"/>
            <a:ext cx="1474048" cy="1101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8458" y="1861595"/>
            <a:ext cx="1474048" cy="1101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999" y="1852182"/>
            <a:ext cx="1474048" cy="1101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7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3728" y="1852182"/>
            <a:ext cx="1474048" cy="1101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3" name="Straight Connector 12"/>
          <p:cNvCxnSpPr/>
          <p:nvPr/>
        </p:nvCxnSpPr>
        <p:spPr>
          <a:xfrm>
            <a:off x="6516530" y="759652"/>
            <a:ext cx="10406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6516636" y="1933791"/>
            <a:ext cx="10406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05" r="63003" b="60562"/>
          <a:stretch/>
        </p:blipFill>
        <p:spPr bwMode="auto">
          <a:xfrm>
            <a:off x="2136990" y="3074485"/>
            <a:ext cx="1490074" cy="11022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4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98" t="63368" r="45505" b="419"/>
          <a:stretch/>
        </p:blipFill>
        <p:spPr bwMode="auto">
          <a:xfrm>
            <a:off x="2153728" y="4227696"/>
            <a:ext cx="1490074" cy="10896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3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568" r="63046" b="59870"/>
          <a:stretch/>
        </p:blipFill>
        <p:spPr bwMode="auto">
          <a:xfrm>
            <a:off x="630264" y="3070911"/>
            <a:ext cx="1490074" cy="11014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" name="Picture 6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10" t="63887" r="45737"/>
          <a:stretch/>
        </p:blipFill>
        <p:spPr bwMode="auto">
          <a:xfrm>
            <a:off x="642631" y="4229394"/>
            <a:ext cx="1490074" cy="10879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9" name="Straight Connector 18"/>
          <p:cNvCxnSpPr/>
          <p:nvPr/>
        </p:nvCxnSpPr>
        <p:spPr>
          <a:xfrm>
            <a:off x="664379" y="3114077"/>
            <a:ext cx="28016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664379" y="4290220"/>
            <a:ext cx="28016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9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7193" y="3025298"/>
            <a:ext cx="2528518" cy="2292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Box 21"/>
          <p:cNvSpPr txBox="1"/>
          <p:nvPr/>
        </p:nvSpPr>
        <p:spPr>
          <a:xfrm rot="16200000">
            <a:off x="-66989" y="1105453"/>
            <a:ext cx="1120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/>
              <a:t>iTTFs</a:t>
            </a:r>
            <a:endParaRPr lang="en-GB" sz="12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-54622" y="2253205"/>
            <a:ext cx="1120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/>
              <a:t>iTTF-Bip</a:t>
            </a:r>
            <a:endParaRPr lang="en-GB" sz="12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-115955" y="4670592"/>
            <a:ext cx="12276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/>
              <a:t>iTTF-Bip</a:t>
            </a:r>
            <a:r>
              <a:rPr lang="en-GB" sz="1200" dirty="0"/>
              <a:t> - zoom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-68254" y="3496370"/>
            <a:ext cx="11207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/>
              <a:t>iTTFs</a:t>
            </a:r>
            <a:r>
              <a:rPr lang="en-GB" sz="1200" dirty="0"/>
              <a:t> - zoom</a:t>
            </a:r>
          </a:p>
        </p:txBody>
      </p:sp>
      <p:sp>
        <p:nvSpPr>
          <p:cNvPr id="26" name="Rectangle 25"/>
          <p:cNvSpPr/>
          <p:nvPr/>
        </p:nvSpPr>
        <p:spPr>
          <a:xfrm>
            <a:off x="664379" y="702715"/>
            <a:ext cx="487687" cy="417547"/>
          </a:xfrm>
          <a:prstGeom prst="rect">
            <a:avLst/>
          </a:prstGeom>
          <a:noFill/>
          <a:ln w="127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/>
          </a:p>
        </p:txBody>
      </p:sp>
      <p:sp>
        <p:nvSpPr>
          <p:cNvPr id="27" name="Rectangle 26"/>
          <p:cNvSpPr/>
          <p:nvPr/>
        </p:nvSpPr>
        <p:spPr>
          <a:xfrm>
            <a:off x="944540" y="2528894"/>
            <a:ext cx="487687" cy="417547"/>
          </a:xfrm>
          <a:prstGeom prst="rect">
            <a:avLst/>
          </a:prstGeom>
          <a:noFill/>
          <a:ln w="127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/>
          </a:p>
        </p:txBody>
      </p:sp>
      <p:sp>
        <p:nvSpPr>
          <p:cNvPr id="28" name="TextBox 27"/>
          <p:cNvSpPr txBox="1"/>
          <p:nvPr/>
        </p:nvSpPr>
        <p:spPr>
          <a:xfrm>
            <a:off x="1009911" y="678657"/>
            <a:ext cx="1143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solidFill>
                  <a:srgbClr val="00FF00"/>
                </a:solidFill>
              </a:rPr>
              <a:t>F-CHP </a:t>
            </a:r>
            <a:r>
              <a:rPr lang="en-GB" sz="1000" b="1" dirty="0">
                <a:solidFill>
                  <a:schemeClr val="bg1"/>
                </a:solidFill>
              </a:rPr>
              <a:t>/</a:t>
            </a:r>
            <a:r>
              <a:rPr lang="en-GB" sz="1000" b="1" dirty="0">
                <a:solidFill>
                  <a:srgbClr val="00FF00"/>
                </a:solidFill>
              </a:rPr>
              <a:t> </a:t>
            </a:r>
            <a:r>
              <a:rPr lang="en-GB" sz="1000" b="1" dirty="0">
                <a:solidFill>
                  <a:srgbClr val="0000FF"/>
                </a:solidFill>
              </a:rPr>
              <a:t>DAPI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485029" y="693189"/>
            <a:ext cx="1143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solidFill>
                  <a:srgbClr val="FF6600"/>
                </a:solidFill>
              </a:rPr>
              <a:t>Col1</a:t>
            </a:r>
            <a:r>
              <a:rPr lang="en-GB" sz="1000" b="1" dirty="0">
                <a:solidFill>
                  <a:srgbClr val="00FF00"/>
                </a:solidFill>
              </a:rPr>
              <a:t> </a:t>
            </a:r>
            <a:r>
              <a:rPr lang="en-GB" sz="1000" b="1" dirty="0">
                <a:solidFill>
                  <a:schemeClr val="bg1"/>
                </a:solidFill>
              </a:rPr>
              <a:t>/</a:t>
            </a:r>
            <a:r>
              <a:rPr lang="en-GB" sz="1000" b="1" dirty="0">
                <a:solidFill>
                  <a:srgbClr val="00FF00"/>
                </a:solidFill>
              </a:rPr>
              <a:t> </a:t>
            </a:r>
            <a:r>
              <a:rPr lang="en-GB" sz="1000" b="1" dirty="0">
                <a:solidFill>
                  <a:srgbClr val="0000FF"/>
                </a:solidFill>
              </a:rPr>
              <a:t>DAPI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008689" y="693189"/>
            <a:ext cx="1143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solidFill>
                  <a:srgbClr val="FF6600"/>
                </a:solidFill>
              </a:rPr>
              <a:t>Col1</a:t>
            </a:r>
            <a:r>
              <a:rPr lang="en-GB" sz="1000" b="1" dirty="0">
                <a:solidFill>
                  <a:srgbClr val="00FF00"/>
                </a:solidFill>
              </a:rPr>
              <a:t> </a:t>
            </a:r>
            <a:r>
              <a:rPr lang="en-GB" sz="1000" b="1" dirty="0">
                <a:solidFill>
                  <a:schemeClr val="bg1"/>
                </a:solidFill>
              </a:rPr>
              <a:t>/</a:t>
            </a:r>
            <a:r>
              <a:rPr lang="en-GB" sz="1000" b="1" dirty="0">
                <a:solidFill>
                  <a:srgbClr val="00FF00"/>
                </a:solidFill>
              </a:rPr>
              <a:t> F-CHP </a:t>
            </a:r>
            <a:r>
              <a:rPr lang="en-GB" sz="1000" b="1" dirty="0">
                <a:solidFill>
                  <a:srgbClr val="0000FF"/>
                </a:solidFill>
              </a:rPr>
              <a:t>DAPI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5190440" y="1540053"/>
            <a:ext cx="1143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bg1"/>
                </a:solidFill>
              </a:rPr>
              <a:t>Merge</a:t>
            </a:r>
            <a:endParaRPr lang="en-GB" sz="1000" b="1" dirty="0">
              <a:solidFill>
                <a:srgbClr val="0000FF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44262" y="3925088"/>
            <a:ext cx="1143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rgbClr val="00FF00"/>
                </a:solidFill>
              </a:rPr>
              <a:t>F-CHP </a:t>
            </a:r>
            <a:r>
              <a:rPr lang="en-GB" sz="1000" b="1" dirty="0">
                <a:solidFill>
                  <a:schemeClr val="bg1"/>
                </a:solidFill>
              </a:rPr>
              <a:t>/</a:t>
            </a:r>
            <a:r>
              <a:rPr lang="en-GB" sz="1000" b="1" dirty="0">
                <a:solidFill>
                  <a:srgbClr val="00FF00"/>
                </a:solidFill>
              </a:rPr>
              <a:t> </a:t>
            </a:r>
            <a:r>
              <a:rPr lang="en-GB" sz="1000" b="1" dirty="0">
                <a:solidFill>
                  <a:srgbClr val="0000FF"/>
                </a:solidFill>
              </a:rPr>
              <a:t>DAPI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153728" y="3929291"/>
            <a:ext cx="1143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bg1"/>
                </a:solidFill>
              </a:rPr>
              <a:t>Merge</a:t>
            </a:r>
            <a:endParaRPr lang="en-GB" sz="1000" b="1" dirty="0">
              <a:solidFill>
                <a:srgbClr val="0000FF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63284" y="5580112"/>
            <a:ext cx="620120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expression retains collagen in a non-helical conformation. 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dentification of non-helical collagen (F-CHP) in control and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overexpressing fibroblasts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gions in A are magnified to show non-helical collagen in swollen ER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overexpressing fibroblasts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istribution of F-CHP staining intensity taken from 10 random chosen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iTTF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iTTF-Bi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cells.  Staining intensity was significantly elevated in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overexpressing cells, 10 randomly selected cells were assessed for staining intensity.  ****p&lt;0.0001. Mann-Whitney U test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07910" y="467544"/>
            <a:ext cx="310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07910" y="2889291"/>
            <a:ext cx="310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823643" y="2889291"/>
            <a:ext cx="310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108044" y="3325004"/>
            <a:ext cx="940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35933074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15053" y="5180290"/>
            <a:ext cx="642631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: siRNA mediated knockdown of HSPA5/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and ATF6 in the U2OS cell line. 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effects of two siRNAs targeting Hspa5/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GNF250999 and GNF251000) are shown in red relative to control samples in blue and positive controls in green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wo further siRNAs were also validated in this screen (GNF251001 and GNF251002) with similar effects on amplitude. 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show the effects of siRNA targeting ATF6. Dampening of circadian rhythm is shown for two of the four tested siRNAs. All traces are taken from http://biogps.org/circadia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Ref. </a:t>
            </a:r>
            <a:r>
              <a:rPr lang="en-GB" sz="1200" smtClean="0">
                <a:latin typeface="Arial" panose="020B0604020202020204" pitchFamily="34" charset="0"/>
                <a:cs typeface="Arial" panose="020B0604020202020204" pitchFamily="34" charset="0"/>
              </a:rPr>
              <a:t>32)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271189" y="683568"/>
            <a:ext cx="6254155" cy="4392487"/>
            <a:chOff x="104428" y="708761"/>
            <a:chExt cx="5556820" cy="3902727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01" t="24809" r="24140" b="45134"/>
            <a:stretch/>
          </p:blipFill>
          <p:spPr bwMode="auto">
            <a:xfrm>
              <a:off x="123478" y="708761"/>
              <a:ext cx="5537770" cy="18369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259" t="25602" r="24140" b="44851"/>
            <a:stretch/>
          </p:blipFill>
          <p:spPr bwMode="auto">
            <a:xfrm>
              <a:off x="104428" y="2805708"/>
              <a:ext cx="5553680" cy="18057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0" name="TextBox 9"/>
          <p:cNvSpPr txBox="1"/>
          <p:nvPr/>
        </p:nvSpPr>
        <p:spPr>
          <a:xfrm>
            <a:off x="315053" y="395536"/>
            <a:ext cx="737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461742" y="400547"/>
            <a:ext cx="737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92630" y="2751036"/>
            <a:ext cx="737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439319" y="2756047"/>
            <a:ext cx="737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1321227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931963" y="7728322"/>
            <a:ext cx="566124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. 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ell viability after 72 hours in response to the indicated doses of PES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traces showing the effects of 10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PES treatment suppresses on baseline and Dexamethasone-induced rhythms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ES treatment, 10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induces the expression of CHOP transcripts after 5hours, suggesting that the unfolded protein response has been activated. **p&lt;0.01, n=3, paired t-test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38829" y="192882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53162" y="2991902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4667" y="5152142"/>
            <a:ext cx="6422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pic>
        <p:nvPicPr>
          <p:cNvPr id="6215" name="Picture 7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2247" y="4937404"/>
            <a:ext cx="3338513" cy="3128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101728" y="523344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**</a:t>
            </a:r>
          </a:p>
        </p:txBody>
      </p:sp>
      <p:pic>
        <p:nvPicPr>
          <p:cNvPr id="6226" name="Picture 8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2699792"/>
            <a:ext cx="3814763" cy="2533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238" name="Picture 9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6184" y="336898"/>
            <a:ext cx="3851275" cy="294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346398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9109585"/>
              </p:ext>
            </p:extLst>
          </p:nvPr>
        </p:nvGraphicFramePr>
        <p:xfrm>
          <a:off x="494665" y="1203339"/>
          <a:ext cx="5868670" cy="307239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206143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016224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646303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b="1" dirty="0">
                          <a:effectLst/>
                        </a:rPr>
                        <a:t>Target</a:t>
                      </a:r>
                      <a:endParaRPr lang="en-GB" sz="1200" b="1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b="1" dirty="0">
                          <a:effectLst/>
                        </a:rPr>
                        <a:t>Forward primer</a:t>
                      </a:r>
                      <a:endParaRPr lang="en-GB" sz="1200" b="1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b="1" dirty="0">
                          <a:effectLst/>
                        </a:rPr>
                        <a:t>Reverse primer</a:t>
                      </a:r>
                      <a:endParaRPr lang="en-GB" sz="1200" b="1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>
                          <a:effectLst/>
                        </a:rPr>
                        <a:t>Rplp0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actggtctaggacccgagaag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ctcccaccttgtctccagtc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Gapdh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cagcctcgtcccgtagacaa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caatctccactttgccactgc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Actb</a:t>
                      </a:r>
                      <a:endParaRPr lang="en-GB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ccaaccgtgaaaagatgacc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accagaggcatacagggaca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Atf4</a:t>
                      </a:r>
                      <a:endParaRPr lang="en-GB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tgatggcttggccagtg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ccattttctccaacatccaatc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Atf6</a:t>
                      </a:r>
                      <a:endParaRPr lang="en-GB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ggacgaggtggtgtcagag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gacagctcttcgctttggac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CHOP/Ddit3</a:t>
                      </a:r>
                      <a:endParaRPr lang="en-GB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gcgacagagccagaataaca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</a:rPr>
                        <a:t>atgactgcacgtggaccag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Xbp1s</a:t>
                      </a:r>
                      <a:endParaRPr lang="en-GB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gagtccgcagcaggtg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gtgtcagagtccatggga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Total Xbp1</a:t>
                      </a:r>
                      <a:endParaRPr lang="en-GB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aagaacacgcttgggaatgg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actccccttggcctccac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Bip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ctgaggcgtatttgggaaag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tcatgacattcagtccagcaa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Col1a1</a:t>
                      </a:r>
                      <a:endParaRPr lang="en-GB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gcctgcttcgtgtaaactcc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ttggtttttggtcacgttca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56033"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>
                          <a:effectLst/>
                        </a:rPr>
                        <a:t>Col1a2</a:t>
                      </a:r>
                      <a:endParaRPr lang="en-GB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</a:pPr>
                      <a:r>
                        <a:rPr lang="en-GB" sz="1100" dirty="0" err="1">
                          <a:effectLst/>
                        </a:rPr>
                        <a:t>caagcatgtctggttaggagag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300"/>
                        </a:lnSpc>
                        <a:spcAft>
                          <a:spcPts val="1000"/>
                        </a:spcAft>
                      </a:pPr>
                      <a:r>
                        <a:rPr lang="en-GB" sz="1100" dirty="0" err="1">
                          <a:effectLst/>
                        </a:rPr>
                        <a:t>aggacaccccttctacgttgt</a:t>
                      </a:r>
                      <a:endParaRPr lang="en-GB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495300" y="701661"/>
            <a:ext cx="497104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Supplementary Table 1: Real-time PCR primers used in this study</a:t>
            </a:r>
            <a:endParaRPr kumimoji="0" lang="en-GB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9152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95</TotalTime>
  <Words>896</Words>
  <Application>Microsoft Office PowerPoint</Application>
  <PresentationFormat>On-screen Show (4:3)</PresentationFormat>
  <Paragraphs>120</Paragraphs>
  <Slides>9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1" baseType="lpstr"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am Pickard</dc:creator>
  <cp:lastModifiedBy>Adam Pickard</cp:lastModifiedBy>
  <cp:revision>304</cp:revision>
  <dcterms:created xsi:type="dcterms:W3CDTF">2017-06-29T14:41:17Z</dcterms:created>
  <dcterms:modified xsi:type="dcterms:W3CDTF">2019-01-31T10:48:18Z</dcterms:modified>
</cp:coreProperties>
</file>